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Override1.xml" ContentType="application/vnd.openxmlformats-officedocument.themeOverride+xml"/>
  <Override PartName="/ppt/notesSlides/notesSlide1.xml" ContentType="application/vnd.openxmlformats-officedocument.presentationml.notesSlide+xml"/>
  <Override PartName="/ppt/theme/themeOverride2.xml" ContentType="application/vnd.openxmlformats-officedocument.themeOverride+xml"/>
  <Override PartName="/ppt/notesSlides/notesSlide2.xml" ContentType="application/vnd.openxmlformats-officedocument.presentationml.notesSlide+xml"/>
  <Override PartName="/ppt/theme/themeOverride3.xml" ContentType="application/vnd.openxmlformats-officedocument.themeOverr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4"/>
  </p:notesMasterIdLst>
  <p:sldIdLst>
    <p:sldId id="267" r:id="rId2"/>
    <p:sldId id="263" r:id="rId3"/>
    <p:sldId id="256" r:id="rId4"/>
    <p:sldId id="257" r:id="rId5"/>
    <p:sldId id="258" r:id="rId6"/>
    <p:sldId id="259" r:id="rId7"/>
    <p:sldId id="260" r:id="rId8"/>
    <p:sldId id="261" r:id="rId9"/>
    <p:sldId id="262" r:id="rId10"/>
    <p:sldId id="264" r:id="rId11"/>
    <p:sldId id="265" r:id="rId12"/>
    <p:sldId id="266" r:id="rId1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4497" autoAdjust="0"/>
  </p:normalViewPr>
  <p:slideViewPr>
    <p:cSldViewPr snapToGrid="0">
      <p:cViewPr varScale="1">
        <p:scale>
          <a:sx n="125" d="100"/>
          <a:sy n="125" d="100"/>
        </p:scale>
        <p:origin x="76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ABAAF9-7DBD-4B42-A901-83B387AFDB9A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142213-0035-4F3D-8DE9-9D2195F6737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4860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E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78944086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6L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1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799704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6M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1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5287521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F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18633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H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9978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I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281407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L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2285048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4M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416263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6B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7326875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6D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9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979005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6E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142213-0035-4F3D-8DE9-9D2195F6737E}" type="slidenum">
              <a:rPr lang="zh-CN" altLang="en-US" smtClean="0"/>
              <a:t>10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29639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3656E3D-F260-8A53-3846-C2F2BF13CE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C4ACE3A-3177-5966-00FB-FAD16D5AA6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6114171-6065-4C61-5852-29D9C820DB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4A98A6-B1EB-3D29-1A11-A17A590DF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165826-680C-59EB-BF59-74B9F3400E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7236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491454-18E9-2472-314A-D80C3021F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8073B1A-6B0C-8C4D-84F9-F37200B078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CAE93F9-5E8B-AAB3-EF34-20D5997F5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9FE4F2B-15EA-ECD9-1837-EF99B1B3EF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C8BFA9C-A2F7-D2C5-D6C3-0F2C2E793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0656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8A56B9C-7545-0C9E-917D-368E3AEF686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60BD3EE-8816-3BD5-FA77-3D7E977846C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DB7BA7-D8BB-74D8-AB54-86CECE4F07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2DC77D-13DE-8131-7869-9FDF607B5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19E41A-892C-8CE0-8078-5A5A6FA686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0818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A6297D0-C06B-D7C6-A79C-EDE2B45F08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67815DF-021A-058F-0C82-9B13067E586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C417BBB-99FC-D41F-EB3C-886DA614F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57FEBC9-A61D-7A1C-BB0C-BDB9F66568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A01B1EE-F43D-2EC6-9D33-2CE803FE1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3244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54C6F1-52F4-9A79-AA9D-1B1AC91EE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418C4F-05E0-7572-9E1C-B52566375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5CE40A9-EC24-020B-8DE1-57FDDEA7C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D4ACDDC-7DC5-9C38-3FA0-857520837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C31F030-989A-A275-7E4B-D709C3A88B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9978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54C674-9C63-A0A0-4479-D7A1D4B622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E335CA0-E543-CB1A-34C7-3E3091C72A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7E2BB4E-33C7-419A-27D6-3DB581E8E10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8C02F62-2B94-10DC-D7FA-18ED9B4729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4CCF74E-AF82-93C4-70AC-A131BEA908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F5305BF-E57E-6FF1-3DE3-FC4FBE0CE5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42417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BD2E02-95B5-BB33-7DC9-01A890DC3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74BECE4-C658-DCC7-D724-B6B4FD9F72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A0B62B89-3A33-994B-E0AF-E0897E1AF9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6F70A90-36CC-D450-CC1F-7809F01E7F7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BADA8A2B-795C-9503-F889-0383FBF1EB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31DB3C6-D2D0-352E-49BB-6A12C417E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0AA30A0-DED2-080E-05D2-659424AE50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68711FC-B502-18AE-8C3A-1A4390CDD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5005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DFFFDA-85FF-E2A2-4FAE-F6E0215A20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84C0711-FEDC-B802-01B7-660EA7703E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18D7D3B3-A44A-CCB9-C836-FC6DEC6AE7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F2F9C74-AD52-0172-0CA7-F3D7C2F7F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2971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A8025FA-8345-7A57-1F2B-28D05F31DE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8B7F703-5C63-D438-80EE-A11CF8594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83949F9-6212-2A98-13DB-2B98679225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8507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84D538-0FA0-E6E9-8E00-743B8AD8E7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D0C778-87E3-9282-63DE-99647BBE9F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6A0839D-868F-9218-7842-DFBC1A754A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89E96AF-A39D-984D-E8C5-BD6E4E9AE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04742E2-8ACA-97D5-30B0-68A90D20A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A937EB-7114-D7F4-46E7-4668CCE04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89729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5A661F1-17E5-CB95-BCBC-8ED4ED0D9F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DA84678-F725-A328-3492-E3F8AE4600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F1A8F18-9BDF-B3F7-8E8F-747FC65C2C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ECA23A-9656-C697-59C3-12653CE012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503684A-F96F-3854-1223-21A626F869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81445ED-8AD9-94DF-2226-2DE84A234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67084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39C6BA4-1C1E-F1E8-56C8-A65AADB20A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284CD1-7574-0AE8-AAA4-C0B1125AD6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F9FADA2-9ADF-E1E1-11F8-E8489F6BF1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207AAD-D650-40B0-9C76-7B9E858306E1}" type="datetimeFigureOut">
              <a:rPr lang="zh-CN" altLang="en-US" smtClean="0"/>
              <a:t>2025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4170ABF-D64B-1AB1-F80A-8D3D667DAE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5674CFD-02EA-3913-B7D9-7D281C44D4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8CF308-0451-4A9E-A1E7-2CEB03C3302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007629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pn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9.png"/><Relationship Id="rId5" Type="http://schemas.openxmlformats.org/officeDocument/2006/relationships/image" Target="../media/image48.png"/><Relationship Id="rId4" Type="http://schemas.openxmlformats.org/officeDocument/2006/relationships/image" Target="../media/image47.png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0" Type="http://schemas.openxmlformats.org/officeDocument/2006/relationships/image" Target="../media/image57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3" Type="http://schemas.openxmlformats.org/officeDocument/2006/relationships/image" Target="../media/image59.png"/><Relationship Id="rId7" Type="http://schemas.openxmlformats.org/officeDocument/2006/relationships/image" Target="../media/image63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2.png"/><Relationship Id="rId5" Type="http://schemas.openxmlformats.org/officeDocument/2006/relationships/image" Target="../media/image61.png"/><Relationship Id="rId10" Type="http://schemas.openxmlformats.org/officeDocument/2006/relationships/image" Target="../media/image66.png"/><Relationship Id="rId4" Type="http://schemas.openxmlformats.org/officeDocument/2006/relationships/image" Target="../media/image60.png"/><Relationship Id="rId9" Type="http://schemas.openxmlformats.org/officeDocument/2006/relationships/image" Target="../media/image65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1.xml"/><Relationship Id="rId6" Type="http://schemas.openxmlformats.org/officeDocument/2006/relationships/image" Target="../media/image3.png"/><Relationship Id="rId5" Type="http://schemas.openxmlformats.org/officeDocument/2006/relationships/image" Target="../media/image2.png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7.png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png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2.png"/><Relationship Id="rId12" Type="http://schemas.openxmlformats.org/officeDocument/2006/relationships/image" Target="../media/image17.png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3.xml"/><Relationship Id="rId6" Type="http://schemas.openxmlformats.org/officeDocument/2006/relationships/image" Target="../media/image11.png"/><Relationship Id="rId11" Type="http://schemas.openxmlformats.org/officeDocument/2006/relationships/image" Target="../media/image16.png"/><Relationship Id="rId5" Type="http://schemas.openxmlformats.org/officeDocument/2006/relationships/image" Target="../media/image10.png"/><Relationship Id="rId10" Type="http://schemas.openxmlformats.org/officeDocument/2006/relationships/image" Target="../media/image15.png"/><Relationship Id="rId4" Type="http://schemas.openxmlformats.org/officeDocument/2006/relationships/image" Target="../media/image9.png"/><Relationship Id="rId9" Type="http://schemas.openxmlformats.org/officeDocument/2006/relationships/image" Target="../media/image14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png"/><Relationship Id="rId3" Type="http://schemas.openxmlformats.org/officeDocument/2006/relationships/image" Target="../media/image27.png"/><Relationship Id="rId7" Type="http://schemas.openxmlformats.org/officeDocument/2006/relationships/image" Target="../media/image31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png"/><Relationship Id="rId5" Type="http://schemas.openxmlformats.org/officeDocument/2006/relationships/image" Target="../media/image29.png"/><Relationship Id="rId10" Type="http://schemas.openxmlformats.org/officeDocument/2006/relationships/image" Target="../media/image34.png"/><Relationship Id="rId4" Type="http://schemas.openxmlformats.org/officeDocument/2006/relationships/image" Target="../media/image28.png"/><Relationship Id="rId9" Type="http://schemas.openxmlformats.org/officeDocument/2006/relationships/image" Target="../media/image3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8.png"/><Relationship Id="rId5" Type="http://schemas.openxmlformats.org/officeDocument/2006/relationships/image" Target="../media/image37.png"/><Relationship Id="rId4" Type="http://schemas.openxmlformats.org/officeDocument/2006/relationships/image" Target="../media/image36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1.png"/><Relationship Id="rId4" Type="http://schemas.openxmlformats.org/officeDocument/2006/relationships/image" Target="../media/image40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5.png"/><Relationship Id="rId5" Type="http://schemas.openxmlformats.org/officeDocument/2006/relationships/image" Target="../media/image44.png"/><Relationship Id="rId4" Type="http://schemas.openxmlformats.org/officeDocument/2006/relationships/image" Target="../media/image4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A99FF1-1BB6-9016-0FC8-5B356CD1E169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Original blots image</a:t>
            </a:r>
            <a:endParaRPr lang="zh-CN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096271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B8087F5-87D2-33DC-EEDD-939987B649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657A63C0-4324-1717-2A94-C7A58A70DAC9}"/>
              </a:ext>
            </a:extLst>
          </p:cNvPr>
          <p:cNvSpPr txBox="1"/>
          <p:nvPr/>
        </p:nvSpPr>
        <p:spPr>
          <a:xfrm>
            <a:off x="1266741" y="1272514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NA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929B7E12-648F-815F-47D0-C86297AD59F1}"/>
              </a:ext>
            </a:extLst>
          </p:cNvPr>
          <p:cNvSpPr txBox="1"/>
          <p:nvPr/>
        </p:nvSpPr>
        <p:spPr>
          <a:xfrm>
            <a:off x="1294176" y="2412705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83C9D6A-1E00-B69B-154A-D4A9400923C5}"/>
              </a:ext>
            </a:extLst>
          </p:cNvPr>
          <p:cNvSpPr txBox="1"/>
          <p:nvPr/>
        </p:nvSpPr>
        <p:spPr>
          <a:xfrm>
            <a:off x="1146517" y="3891298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C5D92B6-83FB-B9B7-695F-53369E68791E}"/>
              </a:ext>
            </a:extLst>
          </p:cNvPr>
          <p:cNvSpPr txBox="1"/>
          <p:nvPr/>
        </p:nvSpPr>
        <p:spPr>
          <a:xfrm>
            <a:off x="1080352" y="5585486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D5AE0ED0-0BB1-BB1C-3803-BBE610EF383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93561" y="607676"/>
            <a:ext cx="1669826" cy="132967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0109E4CB-12FD-2F45-5A08-B6566E62372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H="1">
            <a:off x="2884058" y="5184947"/>
            <a:ext cx="2382851" cy="1170409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B756F376-EF5B-69FD-D6CF-00C3A566A3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884058" y="3483429"/>
            <a:ext cx="2849020" cy="1170408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E87DB162-1055-CB7F-C616-2C2E5C0C46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3018956" y="2200940"/>
            <a:ext cx="2113251" cy="962843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F8E51541-A711-E2D3-DA9F-31E29ED3B453}"/>
              </a:ext>
            </a:extLst>
          </p:cNvPr>
          <p:cNvSpPr txBox="1"/>
          <p:nvPr/>
        </p:nvSpPr>
        <p:spPr>
          <a:xfrm>
            <a:off x="10988070" y="1150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589695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29C635E-321B-AED5-3609-8019018A9E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370199D-9C65-0EB4-D86F-7988D9B520D9}"/>
              </a:ext>
            </a:extLst>
          </p:cNvPr>
          <p:cNvSpPr txBox="1"/>
          <p:nvPr/>
        </p:nvSpPr>
        <p:spPr>
          <a:xfrm>
            <a:off x="4520276" y="5458373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80A5A9FC-7A56-EAAB-B1C2-9DC0E97998E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01649" y="5463689"/>
            <a:ext cx="847843" cy="695422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F6A2ADB-06CD-0104-00C2-710C28204BA5}"/>
              </a:ext>
            </a:extLst>
          </p:cNvPr>
          <p:cNvSpPr txBox="1"/>
          <p:nvPr/>
        </p:nvSpPr>
        <p:spPr>
          <a:xfrm>
            <a:off x="579179" y="622074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NA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7485AC4-E916-BB42-C2EF-D8B2618CD079}"/>
              </a:ext>
            </a:extLst>
          </p:cNvPr>
          <p:cNvSpPr txBox="1"/>
          <p:nvPr/>
        </p:nvSpPr>
        <p:spPr>
          <a:xfrm>
            <a:off x="579178" y="2146074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0118D1CF-BE72-F7BF-107B-3EB18A5C5292}"/>
              </a:ext>
            </a:extLst>
          </p:cNvPr>
          <p:cNvSpPr txBox="1"/>
          <p:nvPr/>
        </p:nvSpPr>
        <p:spPr>
          <a:xfrm>
            <a:off x="579178" y="3429000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233966A4-A0F0-D8A0-C694-DBEA64615CBD}"/>
              </a:ext>
            </a:extLst>
          </p:cNvPr>
          <p:cNvSpPr txBox="1"/>
          <p:nvPr/>
        </p:nvSpPr>
        <p:spPr>
          <a:xfrm>
            <a:off x="634957" y="5173117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C0C857BB-D69C-E79E-8E2D-E492469BE5CF}"/>
              </a:ext>
            </a:extLst>
          </p:cNvPr>
          <p:cNvSpPr txBox="1"/>
          <p:nvPr/>
        </p:nvSpPr>
        <p:spPr>
          <a:xfrm>
            <a:off x="4520276" y="677266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ST1/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37E70D0-8A77-E552-7DA9-D4C4491B2746}"/>
              </a:ext>
            </a:extLst>
          </p:cNvPr>
          <p:cNvSpPr txBox="1"/>
          <p:nvPr/>
        </p:nvSpPr>
        <p:spPr>
          <a:xfrm>
            <a:off x="4544016" y="1831934"/>
            <a:ext cx="12025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MST1/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04A3061-3D8A-F06D-379B-2D838986D0BD}"/>
              </a:ext>
            </a:extLst>
          </p:cNvPr>
          <p:cNvSpPr txBox="1"/>
          <p:nvPr/>
        </p:nvSpPr>
        <p:spPr>
          <a:xfrm>
            <a:off x="4567756" y="2801936"/>
            <a:ext cx="10652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LATS1/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85B2C5E-E889-FBC5-B128-227AF2075500}"/>
              </a:ext>
            </a:extLst>
          </p:cNvPr>
          <p:cNvSpPr txBox="1"/>
          <p:nvPr/>
        </p:nvSpPr>
        <p:spPr>
          <a:xfrm>
            <a:off x="4520276" y="4026890"/>
            <a:ext cx="1270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-LATS1/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940640C8-5CB7-97DA-1FE8-3E8EB8E2B5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63951" y="623774"/>
            <a:ext cx="954106" cy="554712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6CF6E7EC-EA14-2D5D-48CE-8EB29C1E169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068748" y="1831934"/>
            <a:ext cx="944511" cy="554712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57AB1831-4AD2-E114-7F5B-023B216D25F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5946027" y="3812204"/>
            <a:ext cx="1642306" cy="1201482"/>
          </a:xfrm>
          <a:prstGeom prst="rect">
            <a:avLst/>
          </a:prstGeom>
        </p:spPr>
      </p:pic>
      <p:pic>
        <p:nvPicPr>
          <p:cNvPr id="36" name="图片 35">
            <a:extLst>
              <a:ext uri="{FF2B5EF4-FFF2-40B4-BE49-F238E27FC236}">
                <a16:creationId xmlns:a16="http://schemas.microsoft.com/office/drawing/2014/main" id="{E754D68D-522E-8E4C-D47E-8925A770C82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666290" y="2651269"/>
            <a:ext cx="3098446" cy="777731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94D87857-AA4B-DF60-09AB-84EA30C1075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18462" y="432635"/>
            <a:ext cx="1247949" cy="1381318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65C3BD38-C486-1E92-4E61-5DA2A9B6C03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70777" y="3307054"/>
            <a:ext cx="1642306" cy="1227497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8EAC4AAF-CE56-3BCD-50DE-896D533DB7F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970777" y="4991850"/>
            <a:ext cx="1743318" cy="1371791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964666ED-1E59-8355-3AA7-9B80FAB31C5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25762" y="1961408"/>
            <a:ext cx="1888333" cy="1136009"/>
          </a:xfrm>
          <a:prstGeom prst="rect">
            <a:avLst/>
          </a:prstGeom>
        </p:spPr>
      </p:pic>
      <p:sp>
        <p:nvSpPr>
          <p:cNvPr id="50" name="文本框 49">
            <a:extLst>
              <a:ext uri="{FF2B5EF4-FFF2-40B4-BE49-F238E27FC236}">
                <a16:creationId xmlns:a16="http://schemas.microsoft.com/office/drawing/2014/main" id="{DEEF5FD8-080B-B13A-47AF-48300D98CE20}"/>
              </a:ext>
            </a:extLst>
          </p:cNvPr>
          <p:cNvSpPr txBox="1"/>
          <p:nvPr/>
        </p:nvSpPr>
        <p:spPr>
          <a:xfrm>
            <a:off x="10988070" y="115006"/>
            <a:ext cx="11592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L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450002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3359ED8-990D-8C43-413C-A83C41089C9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748D897-9929-4655-805C-DAFBA4551EC7}"/>
              </a:ext>
            </a:extLst>
          </p:cNvPr>
          <p:cNvSpPr txBox="1"/>
          <p:nvPr/>
        </p:nvSpPr>
        <p:spPr>
          <a:xfrm>
            <a:off x="5464438" y="5631864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C5513544-BA97-ED68-686B-EE3CEED26C1B}"/>
              </a:ext>
            </a:extLst>
          </p:cNvPr>
          <p:cNvSpPr txBox="1"/>
          <p:nvPr/>
        </p:nvSpPr>
        <p:spPr>
          <a:xfrm>
            <a:off x="5464438" y="3987362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4FAC00EC-2F99-D19C-A049-9560F4F0D97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104231" y="3743590"/>
            <a:ext cx="1707996" cy="81482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E3CE7407-ABEB-B767-FACB-1276EB931C6C}"/>
              </a:ext>
            </a:extLst>
          </p:cNvPr>
          <p:cNvSpPr txBox="1"/>
          <p:nvPr/>
        </p:nvSpPr>
        <p:spPr>
          <a:xfrm>
            <a:off x="5467095" y="2712192"/>
            <a:ext cx="132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AA443DEA-75A4-3140-AC12-03BAA8060B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031997" y="2283634"/>
            <a:ext cx="1780230" cy="81400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61BA159-3948-A5A3-102F-F685EA4F25C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104231" y="5047001"/>
            <a:ext cx="1707996" cy="1662144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E0031D57-690E-FEB0-24A2-6744B102F565}"/>
              </a:ext>
            </a:extLst>
          </p:cNvPr>
          <p:cNvSpPr txBox="1"/>
          <p:nvPr/>
        </p:nvSpPr>
        <p:spPr>
          <a:xfrm>
            <a:off x="5525444" y="694813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C6AA034-6FB1-2263-13C2-4FD6ED5E60FA}"/>
              </a:ext>
            </a:extLst>
          </p:cNvPr>
          <p:cNvSpPr txBox="1"/>
          <p:nvPr/>
        </p:nvSpPr>
        <p:spPr>
          <a:xfrm>
            <a:off x="544482" y="902774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NA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3984C34-F750-4557-C438-45911DFC647F}"/>
              </a:ext>
            </a:extLst>
          </p:cNvPr>
          <p:cNvSpPr txBox="1"/>
          <p:nvPr/>
        </p:nvSpPr>
        <p:spPr>
          <a:xfrm>
            <a:off x="544481" y="2012104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ST1/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D0E9CCE5-0468-A1DD-8AE0-01F09333C7F8}"/>
              </a:ext>
            </a:extLst>
          </p:cNvPr>
          <p:cNvSpPr txBox="1"/>
          <p:nvPr/>
        </p:nvSpPr>
        <p:spPr>
          <a:xfrm>
            <a:off x="544481" y="4866239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31FD7122-DC13-83E0-3D57-2DCC52CE7F2D}"/>
              </a:ext>
            </a:extLst>
          </p:cNvPr>
          <p:cNvSpPr txBox="1"/>
          <p:nvPr/>
        </p:nvSpPr>
        <p:spPr>
          <a:xfrm>
            <a:off x="565003" y="3491351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3E1D9620-5384-E35A-BF85-1B51E9798B0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2030819" y="2012104"/>
            <a:ext cx="1892886" cy="552527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BD326D7D-1995-B41B-A11C-8EB80D72BA8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31376" y="4740530"/>
            <a:ext cx="1543265" cy="790685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1553E829-0CA7-8BB2-22E3-108B68E5B22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54830" y="484338"/>
            <a:ext cx="1281675" cy="1036991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C52C8357-A361-7F6D-774E-328BA000D40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49057" y="3240874"/>
            <a:ext cx="2460430" cy="730098"/>
          </a:xfrm>
          <a:prstGeom prst="rect">
            <a:avLst/>
          </a:prstGeom>
        </p:spPr>
      </p:pic>
      <p:sp>
        <p:nvSpPr>
          <p:cNvPr id="40" name="文本框 39">
            <a:extLst>
              <a:ext uri="{FF2B5EF4-FFF2-40B4-BE49-F238E27FC236}">
                <a16:creationId xmlns:a16="http://schemas.microsoft.com/office/drawing/2014/main" id="{5712E3C0-E8A6-CC55-DCDE-FD48BE02967F}"/>
              </a:ext>
            </a:extLst>
          </p:cNvPr>
          <p:cNvSpPr txBox="1"/>
          <p:nvPr/>
        </p:nvSpPr>
        <p:spPr>
          <a:xfrm>
            <a:off x="10988070" y="115006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M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F2CD4FD6-512C-C219-D4D8-EF19F23D8C1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031997" y="484338"/>
            <a:ext cx="1409897" cy="9431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72927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>
          <a:extLst>
            <a:ext uri="{FF2B5EF4-FFF2-40B4-BE49-F238E27FC236}">
              <a16:creationId xmlns:a16="http://schemas.microsoft.com/office/drawing/2014/main" id="{BE211598-AA71-6BD9-BA79-5D1F91EB48C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>
            <a:extLst>
              <a:ext uri="{FF2B5EF4-FFF2-40B4-BE49-F238E27FC236}">
                <a16:creationId xmlns:a16="http://schemas.microsoft.com/office/drawing/2014/main" id="{AB621835-30A0-B371-EECD-EE0D3AE37B8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00763" y="2701288"/>
            <a:ext cx="1542316" cy="1455424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7DE7D508-7A36-67E0-90BC-F810FB99575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00763" y="4472842"/>
            <a:ext cx="1686160" cy="152421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950E724-4096-057E-669E-624DD9C4FAAC}"/>
              </a:ext>
            </a:extLst>
          </p:cNvPr>
          <p:cNvSpPr txBox="1"/>
          <p:nvPr/>
        </p:nvSpPr>
        <p:spPr>
          <a:xfrm>
            <a:off x="926125" y="1398002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AFD3599-105E-9008-C0F5-D5CB8F6BEB37}"/>
              </a:ext>
            </a:extLst>
          </p:cNvPr>
          <p:cNvSpPr txBox="1"/>
          <p:nvPr/>
        </p:nvSpPr>
        <p:spPr>
          <a:xfrm>
            <a:off x="926124" y="3118932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D-L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CF78D9D-2723-5C1F-52DE-A03DE4FB3A4D}"/>
              </a:ext>
            </a:extLst>
          </p:cNvPr>
          <p:cNvSpPr txBox="1"/>
          <p:nvPr/>
        </p:nvSpPr>
        <p:spPr>
          <a:xfrm>
            <a:off x="926125" y="4951628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A631016E-3D67-0411-97D8-47FB803AA8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00763" y="820561"/>
            <a:ext cx="1477072" cy="1524213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963526FC-5D40-B3A9-48DB-F3891D1E5CF7}"/>
              </a:ext>
            </a:extLst>
          </p:cNvPr>
          <p:cNvSpPr txBox="1"/>
          <p:nvPr/>
        </p:nvSpPr>
        <p:spPr>
          <a:xfrm>
            <a:off x="10988070" y="1150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E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7801332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49CB6F49-4052-14CD-11DB-6A498FDD0F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3102" y="3837108"/>
            <a:ext cx="2366832" cy="1195679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C414AFD4-D9F1-5128-E56E-79B8EE15619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5704" y="2260656"/>
            <a:ext cx="1232323" cy="993809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ECA47CF-D825-C484-41FD-46A007764D4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93677" y="2260656"/>
            <a:ext cx="993809" cy="874552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466291F3-03B7-6BE9-0761-BB035907C10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3102" y="2306245"/>
            <a:ext cx="1346131" cy="845246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258DA89D-3D6A-0840-A406-10C03D2E7BE5}"/>
              </a:ext>
            </a:extLst>
          </p:cNvPr>
          <p:cNvSpPr txBox="1"/>
          <p:nvPr/>
        </p:nvSpPr>
        <p:spPr>
          <a:xfrm>
            <a:off x="692208" y="2636173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9EE71945-3602-E338-182A-5419C1A77152}"/>
              </a:ext>
            </a:extLst>
          </p:cNvPr>
          <p:cNvSpPr txBox="1"/>
          <p:nvPr/>
        </p:nvSpPr>
        <p:spPr>
          <a:xfrm>
            <a:off x="751518" y="1055706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8692B136-4029-D951-C7A7-35399222C6FB}"/>
              </a:ext>
            </a:extLst>
          </p:cNvPr>
          <p:cNvSpPr txBox="1"/>
          <p:nvPr/>
        </p:nvSpPr>
        <p:spPr>
          <a:xfrm>
            <a:off x="692208" y="4250282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3A31E10E-2BCF-A3EF-1D4D-138C39BD3C1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933102" y="746077"/>
            <a:ext cx="2365772" cy="874551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475FC4C5-FEF8-F9E6-7347-D62A5EB3D6D5}"/>
              </a:ext>
            </a:extLst>
          </p:cNvPr>
          <p:cNvSpPr txBox="1"/>
          <p:nvPr/>
        </p:nvSpPr>
        <p:spPr>
          <a:xfrm>
            <a:off x="10988070" y="115006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F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71236410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>
          <a:extLst>
            <a:ext uri="{FF2B5EF4-FFF2-40B4-BE49-F238E27FC236}">
              <a16:creationId xmlns:a16="http://schemas.microsoft.com/office/drawing/2014/main" id="{05C1BDE6-BC36-5EAB-20DD-ADDCD3A64C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BA268D4-5CE4-313C-E0CD-CDAB39988942}"/>
              </a:ext>
            </a:extLst>
          </p:cNvPr>
          <p:cNvSpPr txBox="1"/>
          <p:nvPr/>
        </p:nvSpPr>
        <p:spPr>
          <a:xfrm>
            <a:off x="698581" y="1736618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7B304058-DBF1-0E18-47F5-3C52F223296D}"/>
              </a:ext>
            </a:extLst>
          </p:cNvPr>
          <p:cNvSpPr txBox="1"/>
          <p:nvPr/>
        </p:nvSpPr>
        <p:spPr>
          <a:xfrm>
            <a:off x="726392" y="3116147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8BD6123A-34FB-34BA-8F6D-C88CB1501380}"/>
              </a:ext>
            </a:extLst>
          </p:cNvPr>
          <p:cNvSpPr txBox="1"/>
          <p:nvPr/>
        </p:nvSpPr>
        <p:spPr>
          <a:xfrm>
            <a:off x="726392" y="50194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686CE81-9CB6-053A-28BF-4B852DA9CD5A}"/>
              </a:ext>
            </a:extLst>
          </p:cNvPr>
          <p:cNvSpPr txBox="1"/>
          <p:nvPr/>
        </p:nvSpPr>
        <p:spPr>
          <a:xfrm>
            <a:off x="2170509" y="475072"/>
            <a:ext cx="1268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V+AG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561368A2-42BE-07AA-5D0F-9A8E1F00239D}"/>
              </a:ext>
            </a:extLst>
          </p:cNvPr>
          <p:cNvSpPr txBox="1"/>
          <p:nvPr/>
        </p:nvSpPr>
        <p:spPr>
          <a:xfrm>
            <a:off x="4831001" y="47507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T3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D9D7965-9496-59A2-D28D-6B8FA6A802E8}"/>
              </a:ext>
            </a:extLst>
          </p:cNvPr>
          <p:cNvSpPr txBox="1"/>
          <p:nvPr/>
        </p:nvSpPr>
        <p:spPr>
          <a:xfrm>
            <a:off x="7268763" y="475072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NU-71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6E4BA4D3-B9F3-9032-A260-6371C0425A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86191" y="1457038"/>
            <a:ext cx="1144865" cy="98653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5DE6F961-99E8-2B1E-F7BB-BABE559CCD7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97127" y="4894463"/>
            <a:ext cx="1056124" cy="953444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8F1EAD09-B870-29B2-F484-A2425754DB2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177474" y="4858565"/>
            <a:ext cx="1307601" cy="980701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DB2F818F-65E6-C890-1570-2EF6319EBA3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74637" y="4792363"/>
            <a:ext cx="1021563" cy="9807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C9971739-FBC3-8B5D-60BE-D867A4BE09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36774" y="1389540"/>
            <a:ext cx="1396789" cy="977752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BD175A9D-5262-94DD-8436-BE5D1A29789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170509" y="2995552"/>
            <a:ext cx="1533739" cy="866896"/>
          </a:xfrm>
          <a:prstGeom prst="rect">
            <a:avLst/>
          </a:prstGeom>
        </p:spPr>
      </p:pic>
      <p:pic>
        <p:nvPicPr>
          <p:cNvPr id="39" name="图片 38">
            <a:extLst>
              <a:ext uri="{FF2B5EF4-FFF2-40B4-BE49-F238E27FC236}">
                <a16:creationId xmlns:a16="http://schemas.microsoft.com/office/drawing/2014/main" id="{7EB5A1D0-290D-937A-586C-5DA31301AF34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 flipH="1">
            <a:off x="6880334" y="1389540"/>
            <a:ext cx="1607420" cy="963573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209E13B9-527A-A004-0306-4F24D53A6A8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880335" y="2949536"/>
            <a:ext cx="1259588" cy="912912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75F25D43-40EB-2985-7BAB-94C29DB45B4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flipH="1">
            <a:off x="4484625" y="3011004"/>
            <a:ext cx="1396789" cy="1052782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F5B39320-5F7F-3AB1-9583-DEC160DE2301}"/>
              </a:ext>
            </a:extLst>
          </p:cNvPr>
          <p:cNvSpPr txBox="1"/>
          <p:nvPr/>
        </p:nvSpPr>
        <p:spPr>
          <a:xfrm>
            <a:off x="10988070" y="115006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7604978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C55584E-B2F4-CE20-5FC1-7267800F5FD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5A6EB27F-8A48-E77E-0241-1D3D54F2257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7451" y="1533967"/>
            <a:ext cx="1857634" cy="847843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1C04592-2D23-63EA-2026-AAAC156AC56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94914" y="1568810"/>
            <a:ext cx="2172003" cy="100026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90F15852-C8A0-B467-02AA-BBF93F55341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53214" y="2748286"/>
            <a:ext cx="1486107" cy="110505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436C280-1EC3-B6D1-60A3-736796197BB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94914" y="3006997"/>
            <a:ext cx="1800476" cy="809738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33A411F-693E-9F08-C1C4-44A4589BB8C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53214" y="4542903"/>
            <a:ext cx="1562318" cy="93358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D701E29-7E6F-1452-27DA-398D0F095B5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561598" y="4682535"/>
            <a:ext cx="1733792" cy="876422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AC727945-54B2-1D21-AD06-8718696FD86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79412" y="4655588"/>
            <a:ext cx="1724266" cy="743054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236EDA54-CC8A-9A5C-CAF3-28A9BD74F13C}"/>
              </a:ext>
            </a:extLst>
          </p:cNvPr>
          <p:cNvSpPr txBox="1"/>
          <p:nvPr/>
        </p:nvSpPr>
        <p:spPr>
          <a:xfrm>
            <a:off x="698581" y="1736618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0E30B76-3ACA-76FF-6299-0AE9A32AE464}"/>
              </a:ext>
            </a:extLst>
          </p:cNvPr>
          <p:cNvSpPr txBox="1"/>
          <p:nvPr/>
        </p:nvSpPr>
        <p:spPr>
          <a:xfrm>
            <a:off x="726392" y="3116147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4028BC1-D8AB-F5E1-D38F-A979D0AA21C6}"/>
              </a:ext>
            </a:extLst>
          </p:cNvPr>
          <p:cNvSpPr txBox="1"/>
          <p:nvPr/>
        </p:nvSpPr>
        <p:spPr>
          <a:xfrm>
            <a:off x="726392" y="50194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D74711AD-43C3-BFB9-9C8C-3CD92FF1928C}"/>
              </a:ext>
            </a:extLst>
          </p:cNvPr>
          <p:cNvSpPr txBox="1"/>
          <p:nvPr/>
        </p:nvSpPr>
        <p:spPr>
          <a:xfrm>
            <a:off x="2170509" y="475072"/>
            <a:ext cx="12682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V+AG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B9E3BAE-83A0-E1C0-CAC1-7BB425B7F5DB}"/>
              </a:ext>
            </a:extLst>
          </p:cNvPr>
          <p:cNvSpPr txBox="1"/>
          <p:nvPr/>
        </p:nvSpPr>
        <p:spPr>
          <a:xfrm>
            <a:off x="4658583" y="492494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T3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3E749B7B-B39E-022C-CD4D-9B0109EA0031}"/>
              </a:ext>
            </a:extLst>
          </p:cNvPr>
          <p:cNvSpPr txBox="1"/>
          <p:nvPr/>
        </p:nvSpPr>
        <p:spPr>
          <a:xfrm>
            <a:off x="6856061" y="586125"/>
            <a:ext cx="1133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NU-71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07104D69-3F19-F0F1-2537-6AF2E823EB7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79412" y="1568810"/>
            <a:ext cx="1604028" cy="813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3F97F098-FA53-46F9-BE37-43526392E3F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79412" y="2731034"/>
            <a:ext cx="1439259" cy="1165680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2C144033-EDEB-32EB-DADC-F9243B10EE6C}"/>
              </a:ext>
            </a:extLst>
          </p:cNvPr>
          <p:cNvSpPr txBox="1"/>
          <p:nvPr/>
        </p:nvSpPr>
        <p:spPr>
          <a:xfrm>
            <a:off x="10988070" y="115006"/>
            <a:ext cx="1095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765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676E919-A457-CA87-306E-70822CC5F83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>
            <a:extLst>
              <a:ext uri="{FF2B5EF4-FFF2-40B4-BE49-F238E27FC236}">
                <a16:creationId xmlns:a16="http://schemas.microsoft.com/office/drawing/2014/main" id="{89983DAF-D995-9976-B2C6-7DFC03B62EDE}"/>
              </a:ext>
            </a:extLst>
          </p:cNvPr>
          <p:cNvSpPr txBox="1"/>
          <p:nvPr/>
        </p:nvSpPr>
        <p:spPr>
          <a:xfrm>
            <a:off x="698581" y="1736618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D276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EEB5FFA4-1B62-B65A-540E-11185CE20833}"/>
              </a:ext>
            </a:extLst>
          </p:cNvPr>
          <p:cNvSpPr txBox="1"/>
          <p:nvPr/>
        </p:nvSpPr>
        <p:spPr>
          <a:xfrm>
            <a:off x="726392" y="3116147"/>
            <a:ext cx="5854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YAP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537521C9-6BBB-6119-1D8E-3C882DDFE763}"/>
              </a:ext>
            </a:extLst>
          </p:cNvPr>
          <p:cNvSpPr txBox="1"/>
          <p:nvPr/>
        </p:nvSpPr>
        <p:spPr>
          <a:xfrm>
            <a:off x="726392" y="5019403"/>
            <a:ext cx="9332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APDH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AC86C60-AD92-5FE7-1473-BF10F56D41D8}"/>
              </a:ext>
            </a:extLst>
          </p:cNvPr>
          <p:cNvSpPr txBox="1"/>
          <p:nvPr/>
        </p:nvSpPr>
        <p:spPr>
          <a:xfrm>
            <a:off x="2170509" y="475072"/>
            <a:ext cx="11448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BV+AGS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1331624-CDDA-DF78-E544-75D0817433ED}"/>
              </a:ext>
            </a:extLst>
          </p:cNvPr>
          <p:cNvSpPr txBox="1"/>
          <p:nvPr/>
        </p:nvSpPr>
        <p:spPr>
          <a:xfrm>
            <a:off x="5073903" y="515592"/>
            <a:ext cx="7040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T38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1B9C9B3-B4F0-5078-19CE-A668F626F51E}"/>
              </a:ext>
            </a:extLst>
          </p:cNvPr>
          <p:cNvSpPr txBox="1"/>
          <p:nvPr/>
        </p:nvSpPr>
        <p:spPr>
          <a:xfrm>
            <a:off x="7353437" y="491309"/>
            <a:ext cx="11063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NU-719</a:t>
            </a:r>
            <a:endParaRPr lang="zh-CN" altLang="en-US" dirty="0"/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167509D3-419E-0E92-3A5A-4F709D7F158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505782" y="2695182"/>
            <a:ext cx="1049504" cy="111247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79122A7B-05A9-0B63-78ED-829E1342B29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61923" y="2535195"/>
            <a:ext cx="1007485" cy="123388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DF50BF9F-0D53-48FA-8395-2E10B02FF7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V="1">
            <a:off x="4962072" y="1188836"/>
            <a:ext cx="1430471" cy="975280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5CEC5DC8-E0DB-D0E6-D3EC-16D348DE0AE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61929" y="4693884"/>
            <a:ext cx="1668605" cy="102037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3DE24903-9061-BB4D-055B-8ABCBE5AD0E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34873" y="4700030"/>
            <a:ext cx="1380501" cy="912331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17CFEAF7-8301-1343-0F71-9705DAABA11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04210" y="1245639"/>
            <a:ext cx="2460891" cy="924334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209CEC11-E7FC-7C49-F0DE-B2004B4E32F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889514" y="1245639"/>
            <a:ext cx="2291101" cy="802532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8254272A-8BCB-CF66-06CB-443A618585E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911402" y="2695182"/>
            <a:ext cx="1733079" cy="1272461"/>
          </a:xfrm>
          <a:prstGeom prst="rect">
            <a:avLst/>
          </a:prstGeom>
        </p:spPr>
      </p:pic>
      <p:sp>
        <p:nvSpPr>
          <p:cNvPr id="39" name="文本框 38">
            <a:extLst>
              <a:ext uri="{FF2B5EF4-FFF2-40B4-BE49-F238E27FC236}">
                <a16:creationId xmlns:a16="http://schemas.microsoft.com/office/drawing/2014/main" id="{13941484-03D3-63F9-FC3E-4CCBA82FB6EC}"/>
              </a:ext>
            </a:extLst>
          </p:cNvPr>
          <p:cNvSpPr txBox="1"/>
          <p:nvPr/>
        </p:nvSpPr>
        <p:spPr>
          <a:xfrm>
            <a:off x="10988070" y="115006"/>
            <a:ext cx="11480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Figure 4L</a:t>
            </a:r>
            <a:endParaRPr lang="zh-CN" altLang="en-US" b="1" dirty="0"/>
          </a:p>
        </p:txBody>
      </p:sp>
    </p:spTree>
    <p:extLst>
      <p:ext uri="{BB962C8B-B14F-4D97-AF65-F5344CB8AC3E}">
        <p14:creationId xmlns:p14="http://schemas.microsoft.com/office/powerpoint/2010/main" val="16461757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2F89D8-83EA-E39F-06E9-06171DA38CC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AFB3A401-723E-29C0-E588-BD64D46EE123}"/>
              </a:ext>
            </a:extLst>
          </p:cNvPr>
          <p:cNvSpPr txBox="1"/>
          <p:nvPr/>
        </p:nvSpPr>
        <p:spPr>
          <a:xfrm>
            <a:off x="687866" y="3244334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8AE9F82-F004-6BD5-E586-A4FEC0306150}"/>
              </a:ext>
            </a:extLst>
          </p:cNvPr>
          <p:cNvSpPr txBox="1"/>
          <p:nvPr/>
        </p:nvSpPr>
        <p:spPr>
          <a:xfrm>
            <a:off x="726392" y="723822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E981D7BB-52FE-9E3C-14A5-01D62B3E23B2}"/>
              </a:ext>
            </a:extLst>
          </p:cNvPr>
          <p:cNvSpPr txBox="1"/>
          <p:nvPr/>
        </p:nvSpPr>
        <p:spPr>
          <a:xfrm>
            <a:off x="726392" y="50194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CA5C91AD-0F0D-AEA2-16D6-41CD66C0D733}"/>
              </a:ext>
            </a:extLst>
          </p:cNvPr>
          <p:cNvSpPr txBox="1"/>
          <p:nvPr/>
        </p:nvSpPr>
        <p:spPr>
          <a:xfrm>
            <a:off x="687865" y="1875811"/>
            <a:ext cx="9284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EAD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F430DB35-3F85-FE8B-1089-91550C9040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49379" y="1820686"/>
            <a:ext cx="2102069" cy="84891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240B278B-B7BD-365C-DF0E-399FEE5ABC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9379" y="372234"/>
            <a:ext cx="1920137" cy="1072508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59C6E493-2F5D-B5E3-6484-8600B8DE665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2716719" y="4460487"/>
            <a:ext cx="1383435" cy="1419423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A4DA6FEA-8F78-CFE2-7345-2B2008787F5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flipH="1">
            <a:off x="2679199" y="3017279"/>
            <a:ext cx="1628734" cy="1095528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463564B2-9667-DEE2-E68D-B43F3EF0C851}"/>
              </a:ext>
            </a:extLst>
          </p:cNvPr>
          <p:cNvSpPr txBox="1"/>
          <p:nvPr/>
        </p:nvSpPr>
        <p:spPr>
          <a:xfrm>
            <a:off x="10988070" y="115006"/>
            <a:ext cx="1223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4M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7142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B7E086-D544-7046-1AAC-08C16898170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D898854B-0FF8-8DD9-279F-1AFCFB0CC573}"/>
              </a:ext>
            </a:extLst>
          </p:cNvPr>
          <p:cNvSpPr txBox="1"/>
          <p:nvPr/>
        </p:nvSpPr>
        <p:spPr>
          <a:xfrm>
            <a:off x="687866" y="3244334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689893B-EAA4-1F57-CD5C-88884B704976}"/>
              </a:ext>
            </a:extLst>
          </p:cNvPr>
          <p:cNvSpPr txBox="1"/>
          <p:nvPr/>
        </p:nvSpPr>
        <p:spPr>
          <a:xfrm>
            <a:off x="864616" y="957738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3419B7DF-5F05-B447-CEC8-9BE4ECF804B7}"/>
              </a:ext>
            </a:extLst>
          </p:cNvPr>
          <p:cNvSpPr txBox="1"/>
          <p:nvPr/>
        </p:nvSpPr>
        <p:spPr>
          <a:xfrm>
            <a:off x="726392" y="5019403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826031F8-BA91-ED33-321C-4DFC670FF5B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5496" y="2876038"/>
            <a:ext cx="1455162" cy="110592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A2A6959-1FDD-E612-E5B9-938F52508E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43574" y="4539996"/>
            <a:ext cx="1602801" cy="1463427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2371C932-4C07-A4D7-BEC4-D3E0F13D7B7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flipH="1">
            <a:off x="1867867" y="741115"/>
            <a:ext cx="1787826" cy="814891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ACEE8F34-1AE7-1F54-B799-9AEAEB8EC506}"/>
              </a:ext>
            </a:extLst>
          </p:cNvPr>
          <p:cNvSpPr txBox="1"/>
          <p:nvPr/>
        </p:nvSpPr>
        <p:spPr>
          <a:xfrm>
            <a:off x="10988070" y="115006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B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256742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A663451-6C19-60D2-B431-4565BBF1B86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21D033DC-D183-1CF6-E171-924A07A7F7C8}"/>
              </a:ext>
            </a:extLst>
          </p:cNvPr>
          <p:cNvSpPr txBox="1"/>
          <p:nvPr/>
        </p:nvSpPr>
        <p:spPr>
          <a:xfrm>
            <a:off x="1266741" y="1272514"/>
            <a:ext cx="941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EBNA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BBD14C65-31B3-4DB8-4322-3FCE8BBAF5DC}"/>
              </a:ext>
            </a:extLst>
          </p:cNvPr>
          <p:cNvSpPr txBox="1"/>
          <p:nvPr/>
        </p:nvSpPr>
        <p:spPr>
          <a:xfrm>
            <a:off x="1294176" y="2412705"/>
            <a:ext cx="6292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YAP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154CE403-0F15-B4B4-49B7-841CAE91892F}"/>
              </a:ext>
            </a:extLst>
          </p:cNvPr>
          <p:cNvSpPr txBox="1"/>
          <p:nvPr/>
        </p:nvSpPr>
        <p:spPr>
          <a:xfrm>
            <a:off x="1266740" y="3585245"/>
            <a:ext cx="9028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D27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260805A-AD8E-6916-157C-5FE25D944C03}"/>
              </a:ext>
            </a:extLst>
          </p:cNvPr>
          <p:cNvSpPr txBox="1"/>
          <p:nvPr/>
        </p:nvSpPr>
        <p:spPr>
          <a:xfrm>
            <a:off x="1294176" y="4803785"/>
            <a:ext cx="10054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F22761FA-4720-7E06-0D48-8BD67978441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18134" y="919787"/>
            <a:ext cx="1651756" cy="991054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AA250EF9-D721-E8A3-FD82-5B147574E33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4721" y="2209036"/>
            <a:ext cx="1985924" cy="921769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5A1EDA16-7D38-7A37-948F-CC60AC61198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2420" y="4614455"/>
            <a:ext cx="1621898" cy="1151024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EED551F4-8E9E-8977-05B5-99917C05EF6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57392" y="3429000"/>
            <a:ext cx="2200582" cy="962159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45A9CB9E-D264-BD41-50C6-AB3A8F5FB048}"/>
              </a:ext>
            </a:extLst>
          </p:cNvPr>
          <p:cNvSpPr txBox="1"/>
          <p:nvPr/>
        </p:nvSpPr>
        <p:spPr>
          <a:xfrm>
            <a:off x="10988070" y="115006"/>
            <a:ext cx="1197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6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81996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24</TotalTime>
  <Words>111</Words>
  <Application>Microsoft Office PowerPoint</Application>
  <PresentationFormat>宽屏</PresentationFormat>
  <Paragraphs>90</Paragraphs>
  <Slides>12</Slides>
  <Notes>11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2</vt:i4>
      </vt:variant>
    </vt:vector>
  </HeadingPairs>
  <TitlesOfParts>
    <vt:vector size="16" baseType="lpstr">
      <vt:lpstr>等线</vt:lpstr>
      <vt:lpstr>等线 Light</vt:lpstr>
      <vt:lpstr>Arial</vt:lpstr>
      <vt:lpstr>Office 主题​​</vt:lpstr>
      <vt:lpstr>Original blots imag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inhao huang</dc:creator>
  <cp:lastModifiedBy>binhao huang</cp:lastModifiedBy>
  <cp:revision>88</cp:revision>
  <dcterms:created xsi:type="dcterms:W3CDTF">2025-02-13T15:19:21Z</dcterms:created>
  <dcterms:modified xsi:type="dcterms:W3CDTF">2025-08-17T16:18:06Z</dcterms:modified>
</cp:coreProperties>
</file>